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0" r:id="rId2"/>
    <p:sldId id="261" r:id="rId3"/>
    <p:sldId id="268" r:id="rId4"/>
    <p:sldId id="266" r:id="rId5"/>
    <p:sldId id="269" r:id="rId6"/>
  </p:sldIdLst>
  <p:sldSz cx="17068800" cy="9601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85" autoAdjust="0"/>
    <p:restoredTop sz="96233" autoAdjust="0"/>
  </p:normalViewPr>
  <p:slideViewPr>
    <p:cSldViewPr snapToGrid="0">
      <p:cViewPr varScale="1">
        <p:scale>
          <a:sx n="51" d="100"/>
          <a:sy n="51" d="100"/>
        </p:scale>
        <p:origin x="44" y="8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C0364-9339-43C9-86EB-4CC054442722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3CC6BF-57CC-419A-BFEB-A95A6429B2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2116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前的</a:t>
            </a:r>
            <a:r>
              <a:rPr lang="en-US" altLang="zh-CN" dirty="0"/>
              <a:t>PF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1850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后</a:t>
            </a:r>
            <a:r>
              <a:rPr lang="en-US" altLang="zh-CN" dirty="0"/>
              <a:t>PF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1801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前</a:t>
            </a:r>
            <a:r>
              <a:rPr lang="en-US" altLang="zh-CN" dirty="0"/>
              <a:t>O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00127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PSM</a:t>
            </a:r>
            <a:r>
              <a:rPr lang="zh-CN" altLang="en-US" dirty="0"/>
              <a:t>后</a:t>
            </a:r>
            <a:r>
              <a:rPr lang="en-US" altLang="zh-CN" dirty="0"/>
              <a:t>OS</a:t>
            </a:r>
            <a:r>
              <a:rPr lang="zh-CN" altLang="en-US" dirty="0"/>
              <a:t>数据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CC6BF-57CC-419A-BFEB-A95A6429B2C1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0582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33600" y="1571308"/>
            <a:ext cx="1280160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33600" y="5042853"/>
            <a:ext cx="128016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383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715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214860" y="511175"/>
            <a:ext cx="3680460" cy="813657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73480" y="511175"/>
            <a:ext cx="10828020" cy="813657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918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0740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4590" y="2393634"/>
            <a:ext cx="1472184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4590" y="6425249"/>
            <a:ext cx="1472184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601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73480" y="2555875"/>
            <a:ext cx="725424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41080" y="2555875"/>
            <a:ext cx="7254240" cy="6091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7994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3" y="511176"/>
            <a:ext cx="14721840" cy="1855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5704" y="2353628"/>
            <a:ext cx="7220902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75704" y="3507105"/>
            <a:ext cx="7220902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641080" y="2353628"/>
            <a:ext cx="7256463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641080" y="3507105"/>
            <a:ext cx="7256463" cy="5158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946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968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0456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4" y="640080"/>
            <a:ext cx="5505132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256463" y="1382396"/>
            <a:ext cx="864108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75704" y="2880360"/>
            <a:ext cx="5505132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086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5704" y="640080"/>
            <a:ext cx="5505132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256463" y="1382396"/>
            <a:ext cx="864108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75704" y="2880360"/>
            <a:ext cx="5505132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275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73480" y="511176"/>
            <a:ext cx="1472184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3480" y="2555875"/>
            <a:ext cx="1472184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73480" y="8898891"/>
            <a:ext cx="384048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D424E-C8CA-472B-BCFE-8D3375C67FEF}" type="datetimeFigureOut">
              <a:rPr lang="zh-CN" altLang="en-US" smtClean="0"/>
              <a:t>2023-10-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54040" y="8898891"/>
            <a:ext cx="576072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054840" y="8898891"/>
            <a:ext cx="384048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33E58-DE8B-4505-AC53-D2D1E1EA3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647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组合 23">
            <a:extLst>
              <a:ext uri="{FF2B5EF4-FFF2-40B4-BE49-F238E27FC236}">
                <a16:creationId xmlns:a16="http://schemas.microsoft.com/office/drawing/2014/main" id="{10371988-D79C-CBF8-4150-E3A72AA3556C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D01D0B2-7610-A900-62ED-E8789109BB54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D52EAEB-6D07-D05C-FCD2-2BBE65B8CB86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EE379BF8-F2F2-28B7-7E76-E52A9D471E3F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E16ECA14-DFB8-4A06-3D3D-8F3B9DE7E452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D5BD2B48-4730-4AE8-C41B-1857AA05A748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2A3E9751-3D5E-E95C-807E-D9ABAC92268D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3 (56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4 (83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63D93233-EA86-100B-FB74-7071037871E1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.2 months (4.8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9.3 months (2.6-4.6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B6DEFF55-9296-D32D-05BB-D39C159C192C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28 (0.23-0.68)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2856C2B2-3DAC-1BB6-5768-B97A8C0141A9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46DC9E8E-CFBC-7258-9C71-A1340ADB47B2}"/>
                </a:ext>
              </a:extLst>
            </p:cNvPr>
            <p:cNvSpPr txBox="1"/>
            <p:nvPr/>
          </p:nvSpPr>
          <p:spPr>
            <a:xfrm>
              <a:off x="5498764" y="1280277"/>
              <a:ext cx="233910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Other Chemotherapy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32731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0DF4A59C-6C5E-8FB1-D59D-E29D62D6F6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86" y="0"/>
            <a:ext cx="16925827" cy="9601200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id="{7293C145-7125-B5C0-B297-96A1556BA7B9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5916B38-AE06-12BB-69D2-ECDB1EFACCF8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00AD41F-E4E9-9C80-9558-DC68CB5D9BE9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01F2466-84C8-3EA9-CE5F-4A9721F505CD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EE0C5170-46CC-9DE2-FE4B-F5B210E4071C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796F7A60-D965-D80B-CE4A-C2100139452F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52D8ECE-09AE-CA53-3512-49308398C7D2}"/>
                </a:ext>
              </a:extLst>
            </p:cNvPr>
            <p:cNvSpPr txBox="1"/>
            <p:nvPr/>
          </p:nvSpPr>
          <p:spPr>
            <a:xfrm>
              <a:off x="8173797" y="1280278"/>
              <a:ext cx="124906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4 (57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04 (88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ACFBB88-4402-1E87-FBE5-7B59E9753A9E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.2 months (4.9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.6 months (3.2-4.5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EC8B994D-6853-FAB5-0AFB-C95481322A0D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8 (0.24-0.60)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07F2B821-76BB-86C4-4E5A-B79FF2639FB5}"/>
                </a:ext>
              </a:extLst>
            </p:cNvPr>
            <p:cNvSpPr txBox="1"/>
            <p:nvPr/>
          </p:nvSpPr>
          <p:spPr>
            <a:xfrm>
              <a:off x="14333003" y="1418776"/>
              <a:ext cx="960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&lt; 0.001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73BEF723-1D8F-EBBE-9C51-7E9CAF991458}"/>
                </a:ext>
              </a:extLst>
            </p:cNvPr>
            <p:cNvSpPr txBox="1"/>
            <p:nvPr/>
          </p:nvSpPr>
          <p:spPr>
            <a:xfrm>
              <a:off x="5498764" y="1280277"/>
              <a:ext cx="233910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Other Chemotherapy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166217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5ACF5CF-4761-BB96-A0C6-13C21AFC63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86" y="0"/>
            <a:ext cx="16925827" cy="9601200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D85B25B9-DF1B-A946-2B8A-B638459FC132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153EDC8D-7221-08E0-74E1-D60904C40347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6ECB2CEA-3E68-7AA0-69E4-7D4AB5965D02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E0F94E9-C926-BD94-B396-D1F1116B2729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B5C2F2C-AABC-8F43-1F44-6318B8BCCCA9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CF21827D-15ED-CBA6-ABAC-C8E03E4DC42C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9701CB2-07A3-5DDC-0393-7E79C3907E7B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3 (56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34 (83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56FD77F-5E57-DB2F-8883-CC9A70109A82}"/>
                </a:ext>
              </a:extLst>
            </p:cNvPr>
            <p:cNvSpPr txBox="1"/>
            <p:nvPr/>
          </p:nvSpPr>
          <p:spPr>
            <a:xfrm>
              <a:off x="9643373" y="1280277"/>
              <a:ext cx="22749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.2 months (4.8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4.0 months (2.6-4.6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BCBD087-5780-9309-5742-CCE5E112FDB3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9 (0.23-0.68)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0071397-77E4-B960-383C-11A9555A6FF9}"/>
                </a:ext>
              </a:extLst>
            </p:cNvPr>
            <p:cNvSpPr txBox="1"/>
            <p:nvPr/>
          </p:nvSpPr>
          <p:spPr>
            <a:xfrm>
              <a:off x="14333003" y="1418776"/>
              <a:ext cx="960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&lt; 0.001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B1F16F5B-80A3-32B5-CCE9-DF5F1024DA40}"/>
                </a:ext>
              </a:extLst>
            </p:cNvPr>
            <p:cNvSpPr txBox="1"/>
            <p:nvPr/>
          </p:nvSpPr>
          <p:spPr>
            <a:xfrm>
              <a:off x="5498764" y="1280277"/>
              <a:ext cx="233910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Other Chemotherapy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590393EC-FDD9-D270-5D82-8FE4C5857DD2}"/>
              </a:ext>
            </a:extLst>
          </p:cNvPr>
          <p:cNvSpPr txBox="1"/>
          <p:nvPr/>
        </p:nvSpPr>
        <p:spPr>
          <a:xfrm rot="10800000">
            <a:off x="72659" y="928058"/>
            <a:ext cx="492443" cy="12304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fter PS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35295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F014730-7615-64F2-B898-87FCA54AFD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86" y="0"/>
            <a:ext cx="16925827" cy="9601200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35BB959F-D09C-E89A-8051-3B04895C60B9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CD523D6-255F-A227-2341-A344501B2895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AE3DB42-11A4-5773-1BF4-AC7DF7C3B739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C734D2BA-1F6A-8FC7-DF41-30F939D7F20A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2D4D618-1A27-FB75-4AFF-9BE9556FE5F8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FAE6225-4F6F-72B7-3147-37F6A424932C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77D38958-BFBA-1EDC-FD37-C2D3A71D62AF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4 (33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89 (76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E525BF5-F04C-E43F-1E2D-D596ADB26125}"/>
                </a:ext>
              </a:extLst>
            </p:cNvPr>
            <p:cNvSpPr txBox="1"/>
            <p:nvPr/>
          </p:nvSpPr>
          <p:spPr>
            <a:xfrm>
              <a:off x="9643373" y="1280277"/>
              <a:ext cx="250151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6.5 months (8.7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0.0 months (9.0-11.9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98100E3-AE59-F78B-BA42-430771ABCDC8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6 (0.19-0.66)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360D1395-CEE5-2BFF-A386-0DB52E2CDEFC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F1D7398-102B-9001-9245-F7AAEFE5CA3C}"/>
                </a:ext>
              </a:extLst>
            </p:cNvPr>
            <p:cNvSpPr txBox="1"/>
            <p:nvPr/>
          </p:nvSpPr>
          <p:spPr>
            <a:xfrm>
              <a:off x="5498764" y="1280277"/>
              <a:ext cx="233910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Other Chemotherapy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74238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D279B4B-EE2A-5AE4-B185-0D2BEFC110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86" y="0"/>
            <a:ext cx="16925827" cy="9601200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0356132F-ECF9-4E10-F865-463287080214}"/>
              </a:ext>
            </a:extLst>
          </p:cNvPr>
          <p:cNvGrpSpPr/>
          <p:nvPr/>
        </p:nvGrpSpPr>
        <p:grpSpPr>
          <a:xfrm>
            <a:off x="6590480" y="589281"/>
            <a:ext cx="9851303" cy="1240808"/>
            <a:chOff x="5498764" y="685801"/>
            <a:chExt cx="9851303" cy="1240808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F1DC680-658C-B88F-5218-3C23122658AA}"/>
                </a:ext>
              </a:extLst>
            </p:cNvPr>
            <p:cNvSpPr txBox="1"/>
            <p:nvPr/>
          </p:nvSpPr>
          <p:spPr>
            <a:xfrm>
              <a:off x="8289214" y="685801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Events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CF8B55D2-FEFD-1972-4A22-A67EAC997645}"/>
                </a:ext>
              </a:extLst>
            </p:cNvPr>
            <p:cNvSpPr txBox="1"/>
            <p:nvPr/>
          </p:nvSpPr>
          <p:spPr>
            <a:xfrm>
              <a:off x="9822910" y="685801"/>
              <a:ext cx="19543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Median (95% CI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142AB2AE-9DAB-5223-572F-F427BBBEEA59}"/>
                </a:ext>
              </a:extLst>
            </p:cNvPr>
            <p:cNvSpPr txBox="1"/>
            <p:nvPr/>
          </p:nvSpPr>
          <p:spPr>
            <a:xfrm>
              <a:off x="14224000" y="685801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p value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89C38D09-114B-6513-3488-6078F9265770}"/>
                </a:ext>
              </a:extLst>
            </p:cNvPr>
            <p:cNvSpPr txBox="1"/>
            <p:nvPr/>
          </p:nvSpPr>
          <p:spPr>
            <a:xfrm>
              <a:off x="12382528" y="685801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R (95%)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664C6520-B7A6-B362-9EBE-02FB1173D5A4}"/>
                </a:ext>
              </a:extLst>
            </p:cNvPr>
            <p:cNvCxnSpPr>
              <a:cxnSpLocks/>
            </p:cNvCxnSpPr>
            <p:nvPr/>
          </p:nvCxnSpPr>
          <p:spPr>
            <a:xfrm>
              <a:off x="5498764" y="1185333"/>
              <a:ext cx="9851303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4D63F6A-E699-C474-C0A0-19318912C16D}"/>
                </a:ext>
              </a:extLst>
            </p:cNvPr>
            <p:cNvSpPr txBox="1"/>
            <p:nvPr/>
          </p:nvSpPr>
          <p:spPr>
            <a:xfrm>
              <a:off x="8173797" y="1280278"/>
              <a:ext cx="112082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3 (32%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8 (68%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0B95267-F2E5-EA19-6F7A-CD0CF30701B2}"/>
                </a:ext>
              </a:extLst>
            </p:cNvPr>
            <p:cNvSpPr txBox="1"/>
            <p:nvPr/>
          </p:nvSpPr>
          <p:spPr>
            <a:xfrm>
              <a:off x="9643373" y="1280277"/>
              <a:ext cx="240322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26.5 months (8.7-NR)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9.3 months (6.9-15.2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AFECBF8-697C-92CD-F3B6-91CA0D527650}"/>
                </a:ext>
              </a:extLst>
            </p:cNvPr>
            <p:cNvSpPr txBox="1"/>
            <p:nvPr/>
          </p:nvSpPr>
          <p:spPr>
            <a:xfrm>
              <a:off x="12068339" y="1418776"/>
              <a:ext cx="18261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37 (0.18-0.75)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6A1FEA6-515B-2634-23C6-454E1FF64E59}"/>
                </a:ext>
              </a:extLst>
            </p:cNvPr>
            <p:cNvSpPr txBox="1"/>
            <p:nvPr/>
          </p:nvSpPr>
          <p:spPr>
            <a:xfrm>
              <a:off x="14333003" y="1418776"/>
              <a:ext cx="7617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.006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FD5265B-043A-9615-D2E6-D865564233B0}"/>
                </a:ext>
              </a:extLst>
            </p:cNvPr>
            <p:cNvSpPr txBox="1"/>
            <p:nvPr/>
          </p:nvSpPr>
          <p:spPr>
            <a:xfrm>
              <a:off x="5498764" y="1280277"/>
              <a:ext cx="233910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Eribulin based</a:t>
              </a:r>
            </a:p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Other Chemotherapy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7D81DF40-9A49-D4F0-CEDC-8526617197E4}"/>
              </a:ext>
            </a:extLst>
          </p:cNvPr>
          <p:cNvSpPr txBox="1"/>
          <p:nvPr/>
        </p:nvSpPr>
        <p:spPr>
          <a:xfrm rot="10800000">
            <a:off x="71486" y="1506922"/>
            <a:ext cx="492443" cy="123046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fter PS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5912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16</TotalTime>
  <Words>227</Words>
  <Application>Microsoft Office PowerPoint</Application>
  <PresentationFormat>自定义</PresentationFormat>
  <Paragraphs>70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xi wang</dc:creator>
  <cp:lastModifiedBy>chenxi wang</cp:lastModifiedBy>
  <cp:revision>45</cp:revision>
  <dcterms:created xsi:type="dcterms:W3CDTF">2023-03-27T12:21:00Z</dcterms:created>
  <dcterms:modified xsi:type="dcterms:W3CDTF">2023-10-18T07:00:59Z</dcterms:modified>
</cp:coreProperties>
</file>